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672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HarrisonR\Documents\USDA%20Sequence%20data\Winter%20moth%20NPV\SNP%20frequenc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dLbls>
            <c:txPr>
              <a:bodyPr/>
              <a:lstStyle/>
              <a:p>
                <a:pPr>
                  <a:defRPr b="1">
                    <a:latin typeface="Arial" pitchFamily="34" charset="0"/>
                    <a:cs typeface="Arial" pitchFamily="34" charset="0"/>
                  </a:defRPr>
                </a:pPr>
                <a:endParaRPr lang="en-US"/>
              </a:p>
            </c:txPr>
            <c:showVal val="1"/>
          </c:dLbls>
          <c:cat>
            <c:strRef>
              <c:f>Sheet1!$D$31:$D$39</c:f>
              <c:strCache>
                <c:ptCount val="9"/>
                <c:pt idx="0">
                  <c:v>0.0 - 0.9</c:v>
                </c:pt>
                <c:pt idx="1">
                  <c:v>1.0 - 1.9</c:v>
                </c:pt>
                <c:pt idx="2">
                  <c:v>2.0 - 2.9</c:v>
                </c:pt>
                <c:pt idx="3">
                  <c:v>3.0 - 3.9</c:v>
                </c:pt>
                <c:pt idx="4">
                  <c:v>4.0 - 4.9</c:v>
                </c:pt>
                <c:pt idx="5">
                  <c:v>5.0 - 5.9</c:v>
                </c:pt>
                <c:pt idx="6">
                  <c:v>6.0 - 6.9</c:v>
                </c:pt>
                <c:pt idx="7">
                  <c:v>7.0 - 7.9</c:v>
                </c:pt>
                <c:pt idx="8">
                  <c:v>≥8.0</c:v>
                </c:pt>
              </c:strCache>
            </c:strRef>
          </c:cat>
          <c:val>
            <c:numRef>
              <c:f>Sheet1!$E$31:$E$39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04</c:v>
                </c:pt>
                <c:pt idx="3">
                  <c:v>90</c:v>
                </c:pt>
                <c:pt idx="4">
                  <c:v>194</c:v>
                </c:pt>
                <c:pt idx="5">
                  <c:v>328</c:v>
                </c:pt>
                <c:pt idx="6">
                  <c:v>128</c:v>
                </c:pt>
                <c:pt idx="7">
                  <c:v>24</c:v>
                </c:pt>
                <c:pt idx="8">
                  <c:v>10</c:v>
                </c:pt>
              </c:numCache>
            </c:numRef>
          </c:val>
        </c:ser>
        <c:axId val="149187968"/>
        <c:axId val="163459072"/>
      </c:barChart>
      <c:catAx>
        <c:axId val="149187968"/>
        <c:scaling>
          <c:orientation val="minMax"/>
        </c:scaling>
        <c:axPos val="b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63459072"/>
        <c:crosses val="autoZero"/>
        <c:auto val="1"/>
        <c:lblAlgn val="ctr"/>
        <c:lblOffset val="100"/>
      </c:catAx>
      <c:valAx>
        <c:axId val="163459072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49187968"/>
        <c:crosses val="autoZero"/>
        <c:crossBetween val="between"/>
      </c:valAx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1309F7-AE57-44CD-813B-2B2946BBECB9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0ECFFDF-25E8-4390-A874-77D94ED42ED0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ECFFDF-25E8-4390-A874-77D94ED42ED0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E728F-3618-47E1-8EC4-D05F4728639F}" type="datetimeFigureOut">
              <a:rPr lang="en-US" smtClean="0"/>
              <a:t>9/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CBF5D-32A5-46C2-9296-F6F76854913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/>
        </p:nvGraphicFramePr>
        <p:xfrm>
          <a:off x="838200" y="1981200"/>
          <a:ext cx="5410200" cy="3429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-561704" y="3300850"/>
            <a:ext cx="24304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No. of SNPs and </a:t>
            </a:r>
            <a:r>
              <a:rPr lang="en-US" sz="1600" b="1" dirty="0" err="1" smtClean="0">
                <a:latin typeface="Arial" pitchFamily="34" charset="0"/>
                <a:cs typeface="Arial" pitchFamily="34" charset="0"/>
              </a:rPr>
              <a:t>indels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819400" y="5562600"/>
            <a:ext cx="159851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Frequency (%)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990600" y="6096000"/>
            <a:ext cx="50292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Figure S1: Frequencies of polymorphisms in the </a:t>
            </a:r>
            <a:r>
              <a:rPr lang="en-US" sz="1200" dirty="0" err="1"/>
              <a:t>OpbuNPV</a:t>
            </a:r>
            <a:r>
              <a:rPr lang="en-US" sz="1200" dirty="0"/>
              <a:t>-MA genome </a:t>
            </a:r>
            <a:r>
              <a:rPr lang="en-US" sz="1200" dirty="0" smtClean="0"/>
              <a:t>assembly.  878 single-nucleotide polymorphisms and small (≤3 </a:t>
            </a:r>
            <a:r>
              <a:rPr lang="en-US" sz="1200" dirty="0" err="1" smtClean="0"/>
              <a:t>bp</a:t>
            </a:r>
            <a:r>
              <a:rPr lang="en-US" sz="1200" dirty="0" smtClean="0"/>
              <a:t>) insertions and deletions are grouped according to their frequency in the assembled sequencing reads.  The number of polymorphisms in each frequency class is indicated above the corresponding bar.</a:t>
            </a:r>
            <a:endParaRPr lang="en-US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arrison, Robert L.</dc:creator>
  <cp:lastModifiedBy> </cp:lastModifiedBy>
  <cp:revision>1</cp:revision>
  <dcterms:created xsi:type="dcterms:W3CDTF">2017-09-04T15:13:59Z</dcterms:created>
  <dcterms:modified xsi:type="dcterms:W3CDTF">2017-09-04T15:21:20Z</dcterms:modified>
</cp:coreProperties>
</file>